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428596" y="6072206"/>
            <a:ext cx="8358246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24: </a:t>
            </a:r>
            <a:r>
              <a:rPr lang="en-GB" sz="1600" dirty="0" smtClean="0"/>
              <a:t>3D model structure and validation of</a:t>
            </a:r>
            <a:r>
              <a:rPr lang="en-US" sz="1600" dirty="0" smtClean="0"/>
              <a:t> KRT20 </a:t>
            </a:r>
            <a:r>
              <a:rPr lang="en-GB" sz="1600" dirty="0" smtClean="0"/>
              <a:t>gene. A) Wild (Template</a:t>
            </a:r>
            <a:r>
              <a:rPr lang="en-US" sz="1600" dirty="0" smtClean="0"/>
              <a:t> 1c1g_A)</a:t>
            </a:r>
            <a:r>
              <a:rPr lang="en-GB" sz="1600" dirty="0" smtClean="0"/>
              <a:t>, B) Mutant (Template</a:t>
            </a:r>
            <a:r>
              <a:rPr lang="en-US" sz="1600" dirty="0" smtClean="0"/>
              <a:t> 1c1g_A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7171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14282" y="428604"/>
            <a:ext cx="3500462" cy="25735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172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643570" y="142875"/>
            <a:ext cx="2538622" cy="2857497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7174" name="Picture 6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14282" y="3153969"/>
            <a:ext cx="3500462" cy="264874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175" name="Picture 7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643570" y="3157559"/>
            <a:ext cx="2500330" cy="2739257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68</cp:revision>
  <dcterms:created xsi:type="dcterms:W3CDTF">2018-05-10T07:33:24Z</dcterms:created>
  <dcterms:modified xsi:type="dcterms:W3CDTF">2018-05-29T07:27:30Z</dcterms:modified>
</cp:coreProperties>
</file>